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-690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D801137-FC7A-BD76-006F-20AD57F06E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859B2C31-CCEC-4CBE-70EF-C705EAC42E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18FFD15-2DCE-0ED4-E9FE-4A1FFE5E7F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99C49-9BEA-4BD9-B044-93B0DC3F6F7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3A89D87-1BD1-9EAF-E5C5-E7412F362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DFA74B4-C7BE-2B13-07AC-0F717151B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A4539-F5FB-48E5-AA61-8F77AEDD2CA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2256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DE9AEA1-2D26-B254-E6DF-6B7233E32A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3951E518-DCC6-E4E5-0B80-BEBCD64C13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83B7D66-4D4A-D3EF-E414-CBC11A16EB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99C49-9BEA-4BD9-B044-93B0DC3F6F7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7DD188F-ED83-51D7-4AFC-13492F5CCC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ECE29D8-9812-83A7-5448-E4E0B2F6B6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A4539-F5FB-48E5-AA61-8F77AEDD2CA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0983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CDE0AA78-19F5-5A6A-E459-23BF79CF89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5B0FDD20-6286-BA2D-1B32-F417941508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4826435-C8BF-587B-AC39-CDE4EAEC5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99C49-9BEA-4BD9-B044-93B0DC3F6F7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1ADA57B-FFFE-C324-B7B3-F4098BFCE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7F6DCF5-7C06-578A-3D26-6CBFA15B4F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A4539-F5FB-48E5-AA61-8F77AEDD2CA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2005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C8C0FFC-BC8F-AAFB-D95A-5A8EEAAAD8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3F20AF9B-94F4-77EA-3D8B-9C1CEDBDE3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51E8C66-17F6-C3FD-9820-1E7DDF9FB2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99C49-9BEA-4BD9-B044-93B0DC3F6F7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D479DB9-68A1-E18B-3BE8-6204592DE0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5C90513-6AE5-179D-3F0F-AD393CD02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A4539-F5FB-48E5-AA61-8F77AEDD2CA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7429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0ACCBD9-8457-5C05-1406-8036E3978B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DCEBF00-E434-3A29-424D-3F566FBACB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83F146C-A521-0757-41DF-88C00E0D96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99C49-9BEA-4BD9-B044-93B0DC3F6F7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954C16C-24A6-1DDB-E095-08DFC5DA05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D64071B-262F-E9BF-714C-CA55AAC138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A4539-F5FB-48E5-AA61-8F77AEDD2CA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8790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0DDEAE6-1103-3674-779B-77377445F2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B8383CC-ACED-5EF9-4D33-38A148AE65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8EEC8489-48EE-7F3F-6D15-D3E49CFB2E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A2307A9D-0861-C4E8-5CC1-E67BBC3C11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99C49-9BEA-4BD9-B044-93B0DC3F6F7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9BE0CE0-51D8-2FF6-EE48-AA38B84B33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05002B1-D4D1-0571-FE0F-AA0E9C1BE0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A4539-F5FB-48E5-AA61-8F77AEDD2CA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0093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B845143-0775-18B0-C9C3-0BAE51593F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F395329C-2FEF-3C01-55AB-05A0BC9EA7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E82659A9-F916-57B4-849A-95AF532141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A4B38A2A-CCFB-0B32-3DA7-124C6C23B0F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4B12B50F-F027-8882-FF0F-564959E094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69B987CD-B306-9C86-6D09-C34985F3F3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99C49-9BEA-4BD9-B044-93B0DC3F6F7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8E85FF14-9702-A276-8A6F-CDE74836F9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B9B17C7B-D5CF-D8C3-8D48-AEBEC5360F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A4539-F5FB-48E5-AA61-8F77AEDD2CA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3512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AADC741-561F-F232-3BA9-4AE38E391B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D469DC4A-F703-E22D-D596-D8158CB10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99C49-9BEA-4BD9-B044-93B0DC3F6F7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241A1E03-6786-08D2-6B43-182C076670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F30DCA99-D3F3-C51A-4F6F-E2D1B4673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A4539-F5FB-48E5-AA61-8F77AEDD2CA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6068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64AC99F3-6866-C773-47BA-8255EE8216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99C49-9BEA-4BD9-B044-93B0DC3F6F7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9A0F9923-02CD-2F41-25F0-2122DE8FD0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5D9F95A1-D155-BB81-3B2A-0D09C00D86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A4539-F5FB-48E5-AA61-8F77AEDD2CA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8458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DB071D0-0687-E801-B636-42C31E6ABB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2386D70-C778-6767-3B6B-00A60FFAF9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0A9819F9-7144-80E9-E3C5-E3820384DC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A8809E7E-8DBD-4CD5-E6EE-A564AA3DE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99C49-9BEA-4BD9-B044-93B0DC3F6F7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A8D8AC4-F05B-E168-80B0-5642826C72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E935CA9E-1780-5E14-AB14-A9C3195D9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A4539-F5FB-48E5-AA61-8F77AEDD2CA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292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8AB5651-CA8A-6D19-CF7E-82A98A5DB9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BB625CE3-407E-BDF6-3784-78154DB023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A2D5A6F4-1565-7F93-AFD1-6498863711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AEEC74EF-919D-6FAC-7B54-E8F558EE07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99C49-9BEA-4BD9-B044-93B0DC3F6F7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77FE5A2F-C212-94CE-1C73-0AB468360E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450B464-999C-A3A4-FD54-96BF5F3662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A4539-F5FB-48E5-AA61-8F77AEDD2CA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5949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42D1E69F-373F-74E3-4765-28FB8600B6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F51C812F-3CF5-022C-1E4A-14DD9810C0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A9C412D-B9DE-69C3-5EB1-FB73B4A3F2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4199C49-9BEA-4BD9-B044-93B0DC3F6F7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FE140C8-95F8-F0D4-7C18-D11282163D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FF722DE-7658-97FD-D60E-677D7565C3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4A4539-F5FB-48E5-AA61-8F77AEDD2CA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21717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a number of people carrying out their carrier&#10;&#10;AI-generated content may be incorrect.">
            <a:extLst>
              <a:ext uri="{FF2B5EF4-FFF2-40B4-BE49-F238E27FC236}">
                <a16:creationId xmlns:a16="http://schemas.microsoft.com/office/drawing/2014/main" xmlns="" id="{FBAB51CA-FEC7-810B-AC5F-4ABE30524BE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5651" y="155456"/>
            <a:ext cx="7240720" cy="453025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E362828B-8030-D9DD-3DE9-254226D39C90}"/>
              </a:ext>
            </a:extLst>
          </p:cNvPr>
          <p:cNvSpPr txBox="1"/>
          <p:nvPr/>
        </p:nvSpPr>
        <p:spPr>
          <a:xfrm>
            <a:off x="2378067" y="4756638"/>
            <a:ext cx="923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i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. </a:t>
            </a:r>
            <a:r>
              <a:rPr lang="es-ES" sz="1200" i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netic diagnostics of ATTRv carriers from 2001 to 2022. Years are distributed biannually.</a:t>
            </a:r>
            <a:endParaRPr lang="en-GB" sz="1200" i="1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94768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xmlns="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9</Words>
  <Application>Microsoft Office PowerPoint</Application>
  <PresentationFormat>Personalizado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Presentación de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c Ventayol Guirado</dc:creator>
  <cp:lastModifiedBy>Marc Ventayol Guirado</cp:lastModifiedBy>
  <cp:revision>2</cp:revision>
  <dcterms:created xsi:type="dcterms:W3CDTF">2025-05-28T09:10:42Z</dcterms:created>
  <dcterms:modified xsi:type="dcterms:W3CDTF">2025-05-28T09:19:03Z</dcterms:modified>
</cp:coreProperties>
</file>